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289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70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599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9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863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296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149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5956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723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471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954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3296AC-BD4C-5A40-BA61-3EA43257002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92BCB2-34AB-D141-90AF-E07A973AE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877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4C38C93-9CF7-C745-B6F2-7B3A3DBF7A00}"/>
              </a:ext>
            </a:extLst>
          </p:cNvPr>
          <p:cNvSpPr txBox="1"/>
          <p:nvPr/>
        </p:nvSpPr>
        <p:spPr>
          <a:xfrm>
            <a:off x="2504560" y="8600022"/>
            <a:ext cx="203132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7DED64A-588A-AC42-9DD2-393AB3B01AD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4186" y="75156"/>
            <a:ext cx="6673814" cy="7008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24302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>
            <a:extLst>
              <a:ext uri="{FF2B5EF4-FFF2-40B4-BE49-F238E27FC236}">
                <a16:creationId xmlns:a16="http://schemas.microsoft.com/office/drawing/2014/main" id="{754B528E-FBD6-7E4E-ACD6-EFF41134E9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382" y="237171"/>
            <a:ext cx="6003235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9. Euler diagram of enriched predicted transcription factors. </a:t>
            </a: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ignificant DEGs analyzed by epigenetic landscape </a:t>
            </a:r>
            <a:r>
              <a:rPr kumimoji="0" lang="en-US" altLang="en-US" sz="12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in silico</a:t>
            </a: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nalysis to identify enrichment of TFs in the respective transcriptomes</a:t>
            </a:r>
            <a:r>
              <a:rPr kumimoji="0" lang="en-US" altLang="en-US" sz="1200" b="0" i="0" u="none" strike="noStrike" cap="none" normalizeH="0" baseline="3000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64</a:t>
            </a: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TF overlaps were overlapped with Euler diagram analyses.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6790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</TotalTime>
  <Words>43</Words>
  <Application>Microsoft Macintosh PowerPoint</Application>
  <PresentationFormat>Letter Paper (8.5x11 in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19:51:21Z</dcterms:created>
  <dcterms:modified xsi:type="dcterms:W3CDTF">2023-02-21T19:53:31Z</dcterms:modified>
</cp:coreProperties>
</file>